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2" r:id="rId2"/>
    <p:sldId id="265" r:id="rId3"/>
    <p:sldId id="266" r:id="rId4"/>
    <p:sldId id="273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A6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1" autoAdjust="0"/>
    <p:restoredTop sz="95128" autoAdjust="0"/>
  </p:normalViewPr>
  <p:slideViewPr>
    <p:cSldViewPr snapToGrid="0">
      <p:cViewPr varScale="1">
        <p:scale>
          <a:sx n="65" d="100"/>
          <a:sy n="65" d="100"/>
        </p:scale>
        <p:origin x="229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v>WT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Analyazed!$J$11,Analyazed!$J$15)</c:f>
                <c:numCache>
                  <c:formatCode>General</c:formatCode>
                  <c:ptCount val="2"/>
                  <c:pt idx="0">
                    <c:v>7.3008393776774497E-2</c:v>
                  </c:pt>
                  <c:pt idx="1">
                    <c:v>7.7118091589799306E-2</c:v>
                  </c:pt>
                </c:numCache>
              </c:numRef>
            </c:plus>
            <c:minus>
              <c:numRef>
                <c:f>(Analyazed!$J$11,Analyazed!$J$15)</c:f>
                <c:numCache>
                  <c:formatCode>General</c:formatCode>
                  <c:ptCount val="2"/>
                  <c:pt idx="0">
                    <c:v>7.3008393776774497E-2</c:v>
                  </c:pt>
                  <c:pt idx="1">
                    <c:v>7.71180915897993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Analyazed!$I$11,Analyazed!$I$15)</c:f>
              <c:numCache>
                <c:formatCode>General</c:formatCode>
                <c:ptCount val="2"/>
                <c:pt idx="0">
                  <c:v>0.77789412302404903</c:v>
                </c:pt>
                <c:pt idx="1">
                  <c:v>0.4805206502425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7E-4E9D-B768-A476761FD80E}"/>
            </c:ext>
          </c:extLst>
        </c:ser>
        <c:ser>
          <c:idx val="0"/>
          <c:order val="1"/>
          <c:tx>
            <c:v>nhx1/2/3/4</c:v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Analyazed!$J$21,Analyazed!$J$25)</c:f>
                <c:numCache>
                  <c:formatCode>General</c:formatCode>
                  <c:ptCount val="2"/>
                  <c:pt idx="0">
                    <c:v>6.5894300000000003E-2</c:v>
                  </c:pt>
                  <c:pt idx="1">
                    <c:v>7.7118091589799306E-2</c:v>
                  </c:pt>
                </c:numCache>
              </c:numRef>
            </c:plus>
            <c:minus>
              <c:numRef>
                <c:f>(Analyazed!$J$21,Analyazed!$J$25)</c:f>
                <c:numCache>
                  <c:formatCode>General</c:formatCode>
                  <c:ptCount val="2"/>
                  <c:pt idx="0">
                    <c:v>6.5894300000000003E-2</c:v>
                  </c:pt>
                  <c:pt idx="1">
                    <c:v>7.71180915897993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2"/>
              <c:pt idx="0">
                <c:v>PIN1</c:v>
              </c:pt>
              <c:pt idx="1">
                <c:v>PIN2</c:v>
              </c:pt>
            </c:strLit>
          </c:cat>
          <c:val>
            <c:numRef>
              <c:f>(Analyazed!$I$21,Analyazed!$I$25)</c:f>
              <c:numCache>
                <c:formatCode>General</c:formatCode>
                <c:ptCount val="2"/>
                <c:pt idx="0">
                  <c:v>0.65016922843589098</c:v>
                </c:pt>
                <c:pt idx="1">
                  <c:v>0.532321132703342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27E-4E9D-B768-A476761FD8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3951472"/>
        <c:axId val="363955392"/>
      </c:barChart>
      <c:catAx>
        <c:axId val="363951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3955392"/>
        <c:crosses val="autoZero"/>
        <c:auto val="1"/>
        <c:lblAlgn val="ctr"/>
        <c:lblOffset val="100"/>
        <c:noMultiLvlLbl val="0"/>
      </c:catAx>
      <c:valAx>
        <c:axId val="3639553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Fold Change</a:t>
                </a:r>
              </a:p>
            </c:rich>
          </c:tx>
          <c:layout>
            <c:manualLayout>
              <c:xMode val="edge"/>
              <c:yMode val="edge"/>
              <c:x val="2.5688396402789301E-2"/>
              <c:y val="0.293128608923884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39514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62009525239154495"/>
          <c:y val="3.03030303030303E-2"/>
          <c:w val="0.34213157930648602"/>
          <c:h val="0.109593414459556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C8C4D9-D6A7-4003-9AB1-B182A3AF64B5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18461C-4FE2-4FB7-BD9E-8DEB2F79B4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6987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18461C-4FE2-4FB7-BD9E-8DEB2F79B4B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6946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130B84-0E90-4380-8079-A7BB120366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F3B65D-B760-4681-A147-BF02EC90B5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50011-D056-41D8-8521-87A07A271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6BE671-4BC7-45FA-B1EA-6D5358DB1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668FA-8343-460C-8B27-921B62515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597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E82365-7301-41CC-981E-BDE9F1C9A0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25EB53-627A-4A7A-ABEA-0F3B69FBDE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A24D62-E84D-4210-8D16-847B804F9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331741-C02C-4BEF-B2F0-FDDC02939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B2B88E-B2C3-45AD-AF1B-2D70D7918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605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D88C1C-7FA6-4881-B47B-7812BBA40E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2536C9-8509-4964-8070-322A78D445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C24C48-BE9C-488F-9B1F-44039F77C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4643A7-3A75-4F0E-9576-C47397AC0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90FA45-2A6A-48D2-A402-FDF7BB37C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671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10F8D6-07F2-4738-B1B4-E40E265F7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9EB98E-EA9F-4A8F-B33A-DC0719DC52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A6CF82-2632-48E9-82E7-CAAA50FE76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042C3D-B466-437B-822A-E20C9CA59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4163FB-71E0-4884-B35E-CD14001DB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05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69EC1-EDB5-4440-A643-9B129B54A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2C3A56-80C9-435A-B345-9458596385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94FE8D-F01A-40AF-B126-A87B8E57C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8D4188-F6AC-4D3E-B5D6-B4AD53AAE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1C7ED5-7421-4E69-ADC8-B5EDF2FDF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413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212E4C-33E6-42A4-9661-83CE7B08C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68E594-75FA-49DB-9DB7-75247EBCC1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022662-D1AA-46D0-97B7-965C5E6124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CF9AC1-410D-4BBE-A73C-A983B6F59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20F1E7-8D7D-4746-83E9-AE50E3285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80D206-224A-4607-AC9C-4C4D3E82E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051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EB700F-A4B5-4DF1-B610-2ACF0E0F7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53EF2E-0D42-4288-B7CC-134DD68145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3588A0-1B66-43CE-AB9B-58CAF5DA3F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A789FF-ACA3-4313-AA0E-DA9562A347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A13293-211D-43C8-A6FB-052071F432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154578-06EB-4D8B-B99C-54D971DCE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F6FE4AD-B00A-4424-BA25-48DD7D454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0DD90A5-AF89-4CDC-80D2-2619C8847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720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9F997-C3E6-46B9-9435-C6CF783435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7CF86B1-758E-45AF-977F-55DFB2582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5D306C-8FE6-4DB1-AA72-C38ACA3D2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A5CA08-0ABA-4EDE-9F54-02EB31553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206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B49B01A-DE49-4BFC-A3B5-3BC143357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BDE0EE-9F18-4D92-957F-8DFCB3BE2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A98E93-974D-46D7-B3E9-EB85DB853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823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FBB63F-ABBB-40BE-8681-37EC89AEE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14E24E-16D6-4400-8C87-D5A8F443BC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DC77DC-2C3B-43B6-9B69-0AB1746C91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5ADFBA-BDBB-4CA6-A4F3-6EC5B60CE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463C33-1BE4-4FB8-99F6-66023DB92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17D3D7-E4CB-4B40-8A39-4AF4E8254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914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7735F-95AD-4157-A468-ABF70F7872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65DDD1-1F42-4C6A-ABD4-82D4CEAF3B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494814-CF78-42E3-BDA2-A479E3E1B9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0440DA-6F57-42D0-A271-5C49E6C3D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EBC686-5522-4153-AAF2-CD47369DF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159325-2306-42F3-8033-007CF6661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427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0885A7-C625-4A9A-852E-9501317A9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AFE47C-D3BB-4E56-A983-C402B7CAF3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A1FDB1-715E-4BC5-9F6B-B51FFB2AEE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113805-1531-4AA1-BD7A-FF459DA34F07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AD6A63-25AB-4C8E-81A3-A15D1C852B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BBA230-B06F-4B40-B649-7B13CDC466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56C68-586F-47C5-A051-7C15EC3A73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255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13" Type="http://schemas.openxmlformats.org/officeDocument/2006/relationships/image" Target="../media/image13.tif"/><Relationship Id="rId3" Type="http://schemas.openxmlformats.org/officeDocument/2006/relationships/image" Target="../media/image3.tif"/><Relationship Id="rId7" Type="http://schemas.openxmlformats.org/officeDocument/2006/relationships/image" Target="../media/image7.tiff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" Type="http://schemas.openxmlformats.org/officeDocument/2006/relationships/image" Target="../media/image2.tiff"/><Relationship Id="rId16" Type="http://schemas.openxmlformats.org/officeDocument/2006/relationships/image" Target="../media/image1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11" Type="http://schemas.openxmlformats.org/officeDocument/2006/relationships/image" Target="../media/image11.png"/><Relationship Id="rId5" Type="http://schemas.openxmlformats.org/officeDocument/2006/relationships/image" Target="../media/image5.tiff"/><Relationship Id="rId15" Type="http://schemas.openxmlformats.org/officeDocument/2006/relationships/image" Target="../media/image15.tif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tif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12C6C66D-A9AE-4A4D-B6F7-A5028E26328F}"/>
              </a:ext>
            </a:extLst>
          </p:cNvPr>
          <p:cNvCxnSpPr>
            <a:cxnSpLocks/>
          </p:cNvCxnSpPr>
          <p:nvPr/>
        </p:nvCxnSpPr>
        <p:spPr>
          <a:xfrm flipH="1">
            <a:off x="5146133" y="1780852"/>
            <a:ext cx="8053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D8DB5CBD-1C4B-47A9-B22D-9E5B3AE1A7B8}"/>
              </a:ext>
            </a:extLst>
          </p:cNvPr>
          <p:cNvCxnSpPr>
            <a:cxnSpLocks/>
          </p:cNvCxnSpPr>
          <p:nvPr/>
        </p:nvCxnSpPr>
        <p:spPr>
          <a:xfrm>
            <a:off x="5164073" y="1677437"/>
            <a:ext cx="774314" cy="2057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DFFAD9A4-91E2-4750-AC90-DDB14F577AE0}"/>
              </a:ext>
            </a:extLst>
          </p:cNvPr>
          <p:cNvCxnSpPr>
            <a:cxnSpLocks/>
          </p:cNvCxnSpPr>
          <p:nvPr/>
        </p:nvCxnSpPr>
        <p:spPr>
          <a:xfrm>
            <a:off x="5206234" y="1577289"/>
            <a:ext cx="694284" cy="4007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5CF458C7-2E27-4FE3-84B3-886B2BCDA31F}"/>
              </a:ext>
            </a:extLst>
          </p:cNvPr>
          <p:cNvCxnSpPr>
            <a:cxnSpLocks/>
          </p:cNvCxnSpPr>
          <p:nvPr/>
        </p:nvCxnSpPr>
        <p:spPr>
          <a:xfrm>
            <a:off x="5270300" y="1494378"/>
            <a:ext cx="571560" cy="5672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A09FADF0-EAB3-45AE-A86D-0A28323E6D15}"/>
              </a:ext>
            </a:extLst>
          </p:cNvPr>
          <p:cNvCxnSpPr>
            <a:cxnSpLocks/>
          </p:cNvCxnSpPr>
          <p:nvPr/>
        </p:nvCxnSpPr>
        <p:spPr>
          <a:xfrm>
            <a:off x="5354658" y="1430405"/>
            <a:ext cx="400178" cy="7008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CB0E546-CB77-49EC-8580-53E1CA424E36}"/>
              </a:ext>
            </a:extLst>
          </p:cNvPr>
          <p:cNvCxnSpPr>
            <a:cxnSpLocks/>
          </p:cNvCxnSpPr>
          <p:nvPr/>
        </p:nvCxnSpPr>
        <p:spPr>
          <a:xfrm>
            <a:off x="5448906" y="1390919"/>
            <a:ext cx="207271" cy="7734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19647F7-B4B2-44AD-AFAC-FD41E474B943}"/>
              </a:ext>
            </a:extLst>
          </p:cNvPr>
          <p:cNvCxnSpPr>
            <a:cxnSpLocks/>
          </p:cNvCxnSpPr>
          <p:nvPr/>
        </p:nvCxnSpPr>
        <p:spPr>
          <a:xfrm>
            <a:off x="5551230" y="1373404"/>
            <a:ext cx="0" cy="8156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9732257C-7277-4994-B3D6-7F64E01C68DA}"/>
              </a:ext>
            </a:extLst>
          </p:cNvPr>
          <p:cNvCxnSpPr>
            <a:cxnSpLocks/>
          </p:cNvCxnSpPr>
          <p:nvPr/>
        </p:nvCxnSpPr>
        <p:spPr>
          <a:xfrm flipV="1">
            <a:off x="5164073" y="1673083"/>
            <a:ext cx="774314" cy="213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8202D2F9-D79B-4A5E-AEAB-7D339FB2F7A1}"/>
              </a:ext>
            </a:extLst>
          </p:cNvPr>
          <p:cNvCxnSpPr>
            <a:cxnSpLocks/>
          </p:cNvCxnSpPr>
          <p:nvPr/>
        </p:nvCxnSpPr>
        <p:spPr>
          <a:xfrm flipV="1">
            <a:off x="5197214" y="1581482"/>
            <a:ext cx="703304" cy="3938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37D02A02-B021-43C3-AC94-76D3877860B8}"/>
              </a:ext>
            </a:extLst>
          </p:cNvPr>
          <p:cNvCxnSpPr>
            <a:cxnSpLocks/>
          </p:cNvCxnSpPr>
          <p:nvPr/>
        </p:nvCxnSpPr>
        <p:spPr>
          <a:xfrm flipV="1">
            <a:off x="5270300" y="1494378"/>
            <a:ext cx="571560" cy="5712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4BF5FCF3-5ADB-4399-8F3E-365458E4F82E}"/>
              </a:ext>
            </a:extLst>
          </p:cNvPr>
          <p:cNvCxnSpPr>
            <a:cxnSpLocks/>
          </p:cNvCxnSpPr>
          <p:nvPr/>
        </p:nvCxnSpPr>
        <p:spPr>
          <a:xfrm flipV="1">
            <a:off x="5352481" y="1428517"/>
            <a:ext cx="400178" cy="6975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0FE211F5-6AF1-4630-96B1-38770382378C}"/>
              </a:ext>
            </a:extLst>
          </p:cNvPr>
          <p:cNvCxnSpPr>
            <a:cxnSpLocks/>
          </p:cNvCxnSpPr>
          <p:nvPr/>
        </p:nvCxnSpPr>
        <p:spPr>
          <a:xfrm flipV="1">
            <a:off x="5448213" y="1386565"/>
            <a:ext cx="209178" cy="7777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Oval 35">
            <a:extLst>
              <a:ext uri="{FF2B5EF4-FFF2-40B4-BE49-F238E27FC236}">
                <a16:creationId xmlns:a16="http://schemas.microsoft.com/office/drawing/2014/main" id="{9EE56F29-FBC7-4409-B246-A8797AE282CD}"/>
              </a:ext>
            </a:extLst>
          </p:cNvPr>
          <p:cNvSpPr/>
          <p:nvPr/>
        </p:nvSpPr>
        <p:spPr>
          <a:xfrm>
            <a:off x="5166613" y="1394811"/>
            <a:ext cx="774314" cy="767001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9" name="Picture 108"/>
          <p:cNvPicPr>
            <a:picLocks noChangeAspect="1"/>
          </p:cNvPicPr>
          <p:nvPr/>
        </p:nvPicPr>
        <p:blipFill rotWithShape="1">
          <a:blip r:embed="rId3"/>
          <a:srcRect l="1" t="1850" r="33662" b="19579"/>
          <a:stretch/>
        </p:blipFill>
        <p:spPr>
          <a:xfrm>
            <a:off x="877005" y="1026332"/>
            <a:ext cx="3662075" cy="151926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00028" y="4323994"/>
            <a:ext cx="566635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S1. </a:t>
            </a:r>
            <a:r>
              <a:rPr lang="en-US" altLang="zh-CN" sz="1200" dirty="0"/>
              <a:t>Root response to gravistimulation </a:t>
            </a:r>
            <a:r>
              <a:rPr lang="en-US" sz="1200" dirty="0"/>
              <a:t>of </a:t>
            </a:r>
            <a:r>
              <a:rPr lang="en-US" sz="1200" i="1" dirty="0"/>
              <a:t>nhx1nhx2nhx3nhx4 </a:t>
            </a:r>
            <a:r>
              <a:rPr lang="en-US" sz="1200" dirty="0"/>
              <a:t>mutant. (</a:t>
            </a:r>
            <a:r>
              <a:rPr lang="en-US" sz="1200" b="1" dirty="0"/>
              <a:t>a</a:t>
            </a:r>
            <a:r>
              <a:rPr lang="en-US" sz="1200" dirty="0"/>
              <a:t>)</a:t>
            </a:r>
            <a:r>
              <a:rPr lang="en-US" altLang="zh-CN" sz="1200" dirty="0"/>
              <a:t>, Gravistimulation response of </a:t>
            </a:r>
            <a:r>
              <a:rPr lang="en-US" sz="1200" i="1" dirty="0"/>
              <a:t>nhx1nhx2nhx3nhx4 (nhx1/2/3/4)</a:t>
            </a:r>
            <a:r>
              <a:rPr lang="en-US" altLang="zh-CN" sz="1200" dirty="0"/>
              <a:t> roots after 6 days of gravity change under 1mM </a:t>
            </a:r>
            <a:r>
              <a:rPr lang="en-US" altLang="zh-CN" sz="1200" dirty="0" err="1"/>
              <a:t>KCl</a:t>
            </a:r>
            <a:r>
              <a:rPr lang="en-US" altLang="zh-CN" sz="1200" dirty="0"/>
              <a:t> and 30mM </a:t>
            </a:r>
            <a:r>
              <a:rPr lang="en-US" altLang="zh-CN" sz="1200" dirty="0" err="1"/>
              <a:t>KCl</a:t>
            </a:r>
            <a:r>
              <a:rPr lang="en-US" altLang="zh-CN" sz="1200" dirty="0"/>
              <a:t>. Yellow dots, gravistimulation started by turning the plates by 90⁰.  Red arrows, highlights of gravitropism loss in </a:t>
            </a:r>
            <a:r>
              <a:rPr lang="en-US" sz="1200" i="1" dirty="0"/>
              <a:t>nhx1nhx2nhx3nhx4</a:t>
            </a:r>
            <a:r>
              <a:rPr lang="en-US" altLang="zh-CN" sz="1200" i="1" dirty="0"/>
              <a:t> </a:t>
            </a:r>
            <a:r>
              <a:rPr lang="en-US" altLang="zh-CN" sz="1200" dirty="0"/>
              <a:t>roots</a:t>
            </a:r>
            <a:r>
              <a:rPr lang="en-US" altLang="zh-CN" sz="1200" i="1" dirty="0"/>
              <a:t>. </a:t>
            </a:r>
            <a:r>
              <a:rPr lang="en-US" altLang="zh-CN" sz="1200" dirty="0"/>
              <a:t>Arrow indicates the gravity vector. (</a:t>
            </a:r>
            <a:r>
              <a:rPr lang="en-US" altLang="zh-CN" sz="1200" b="1" dirty="0"/>
              <a:t>b</a:t>
            </a:r>
            <a:r>
              <a:rPr lang="en-US" altLang="zh-CN" sz="1200" dirty="0"/>
              <a:t>), Measurement of the angle (</a:t>
            </a:r>
            <a:r>
              <a:rPr lang="zh-CN" altLang="en-US" sz="1200" dirty="0"/>
              <a:t>𝜃</a:t>
            </a:r>
            <a:r>
              <a:rPr lang="en-US" altLang="zh-CN" sz="1200" dirty="0"/>
              <a:t>). (</a:t>
            </a:r>
            <a:r>
              <a:rPr lang="en-US" altLang="zh-CN" sz="1200" b="1" dirty="0"/>
              <a:t>c</a:t>
            </a:r>
            <a:r>
              <a:rPr lang="en-US" altLang="zh-CN" sz="1200" dirty="0"/>
              <a:t>), Measuring the angle formed by the root growth after the gravistimulation centered by the yellow dots shown in </a:t>
            </a:r>
            <a:r>
              <a:rPr lang="en-US" altLang="zh-CN" sz="1200" b="1" dirty="0"/>
              <a:t>a</a:t>
            </a:r>
            <a:r>
              <a:rPr lang="en-US" altLang="zh-CN" sz="1200" dirty="0"/>
              <a:t>. The length of the bars is proportional to the number of plants observed in each 15° bin. n=15.</a:t>
            </a:r>
            <a:endParaRPr 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1914797" y="1012734"/>
            <a:ext cx="228600" cy="2051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aseline="30000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88047" y="1012734"/>
            <a:ext cx="228600" cy="2051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aseline="30000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473700" y="2813050"/>
            <a:ext cx="228600" cy="2051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aseline="30000" dirty="0">
                <a:solidFill>
                  <a:schemeClr val="bg1"/>
                </a:solidFill>
              </a:rPr>
              <a:t>+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5AFBBCA-9082-4D99-9011-4E5E9FFAD974}"/>
              </a:ext>
            </a:extLst>
          </p:cNvPr>
          <p:cNvSpPr txBox="1"/>
          <p:nvPr/>
        </p:nvSpPr>
        <p:spPr>
          <a:xfrm>
            <a:off x="883941" y="1012734"/>
            <a:ext cx="374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(</a:t>
            </a:r>
            <a:r>
              <a:rPr lang="en-US" altLang="zh-CN" sz="1200" b="1" dirty="0">
                <a:solidFill>
                  <a:schemeClr val="bg1"/>
                </a:solidFill>
              </a:rPr>
              <a:t>a</a:t>
            </a:r>
            <a:r>
              <a:rPr lang="en-US" sz="1200" b="1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5C967993-0436-4640-95E0-E5B5F22731B0}"/>
              </a:ext>
            </a:extLst>
          </p:cNvPr>
          <p:cNvSpPr/>
          <p:nvPr/>
        </p:nvSpPr>
        <p:spPr>
          <a:xfrm>
            <a:off x="1004967" y="2948164"/>
            <a:ext cx="583287" cy="583287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3DF3BA-5162-4DBA-89AA-AFDF5B5AACC4}"/>
              </a:ext>
            </a:extLst>
          </p:cNvPr>
          <p:cNvSpPr txBox="1"/>
          <p:nvPr/>
        </p:nvSpPr>
        <p:spPr>
          <a:xfrm>
            <a:off x="1105475" y="3117799"/>
            <a:ext cx="4127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 </a:t>
            </a:r>
            <a:endParaRPr lang="en-US" sz="12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BADBC5D-EDDF-4D00-99B7-C04FEB024253}"/>
              </a:ext>
            </a:extLst>
          </p:cNvPr>
          <p:cNvSpPr/>
          <p:nvPr/>
        </p:nvSpPr>
        <p:spPr>
          <a:xfrm>
            <a:off x="1258510" y="3531451"/>
            <a:ext cx="89358" cy="583287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6AFA330E-F6AD-4ADE-BF2C-EEA6257F20F4}"/>
              </a:ext>
            </a:extLst>
          </p:cNvPr>
          <p:cNvSpPr/>
          <p:nvPr/>
        </p:nvSpPr>
        <p:spPr>
          <a:xfrm>
            <a:off x="1950077" y="2948164"/>
            <a:ext cx="583287" cy="583287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B394BE1E-C1B4-44B4-BADC-DFC202A37ECF}"/>
              </a:ext>
            </a:extLst>
          </p:cNvPr>
          <p:cNvSpPr/>
          <p:nvPr/>
        </p:nvSpPr>
        <p:spPr>
          <a:xfrm>
            <a:off x="2912173" y="2948164"/>
            <a:ext cx="583287" cy="583287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469BB9B-38DB-48FE-A779-CEEFC5932721}"/>
              </a:ext>
            </a:extLst>
          </p:cNvPr>
          <p:cNvSpPr txBox="1"/>
          <p:nvPr/>
        </p:nvSpPr>
        <p:spPr>
          <a:xfrm>
            <a:off x="3012681" y="3117799"/>
            <a:ext cx="4127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 </a:t>
            </a:r>
            <a:endParaRPr lang="en-US" sz="1200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1FA0858-0A2B-4558-AFC3-6727D88972A5}"/>
              </a:ext>
            </a:extLst>
          </p:cNvPr>
          <p:cNvSpPr/>
          <p:nvPr/>
        </p:nvSpPr>
        <p:spPr>
          <a:xfrm>
            <a:off x="3165716" y="3531451"/>
            <a:ext cx="89358" cy="583287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FB37B43-3B34-4A89-BE16-3015A824FB09}"/>
              </a:ext>
            </a:extLst>
          </p:cNvPr>
          <p:cNvSpPr/>
          <p:nvPr/>
        </p:nvSpPr>
        <p:spPr>
          <a:xfrm>
            <a:off x="1902634" y="3017882"/>
            <a:ext cx="68294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/>
              <a:t>nhx1/2/</a:t>
            </a:r>
          </a:p>
          <a:p>
            <a:r>
              <a:rPr lang="en-US" altLang="zh-CN" sz="1200" i="1" dirty="0"/>
              <a:t>3/4</a:t>
            </a:r>
            <a:r>
              <a:rPr lang="en-US" altLang="zh-CN" sz="1200" dirty="0"/>
              <a:t> </a:t>
            </a:r>
            <a:endParaRPr lang="en-US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4C221EB-0850-482A-84D5-3D34E6D1CE81}"/>
              </a:ext>
            </a:extLst>
          </p:cNvPr>
          <p:cNvSpPr txBox="1"/>
          <p:nvPr/>
        </p:nvSpPr>
        <p:spPr>
          <a:xfrm>
            <a:off x="877800" y="2541583"/>
            <a:ext cx="374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</a:t>
            </a:r>
            <a:r>
              <a:rPr lang="en-US" altLang="zh-CN" sz="1200" b="1" dirty="0"/>
              <a:t>c</a:t>
            </a:r>
            <a:r>
              <a:rPr lang="en-US" sz="1200" b="1" dirty="0"/>
              <a:t>)</a:t>
            </a:r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B944FED6-0AC6-4B01-AF68-BE5806EEB0D8}"/>
              </a:ext>
            </a:extLst>
          </p:cNvPr>
          <p:cNvSpPr/>
          <p:nvPr/>
        </p:nvSpPr>
        <p:spPr>
          <a:xfrm>
            <a:off x="3742679" y="3378689"/>
            <a:ext cx="583287" cy="583287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D63D8A6-B159-47E7-9725-D6E9B3A8DB46}"/>
              </a:ext>
            </a:extLst>
          </p:cNvPr>
          <p:cNvSpPr/>
          <p:nvPr/>
        </p:nvSpPr>
        <p:spPr>
          <a:xfrm>
            <a:off x="3989643" y="3230327"/>
            <a:ext cx="83036" cy="149989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09CA346-03FA-4690-93BF-253D1A66C0B2}"/>
              </a:ext>
            </a:extLst>
          </p:cNvPr>
          <p:cNvSpPr/>
          <p:nvPr/>
        </p:nvSpPr>
        <p:spPr>
          <a:xfrm>
            <a:off x="3695236" y="3448407"/>
            <a:ext cx="68294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/>
              <a:t>nhx1/2/</a:t>
            </a:r>
          </a:p>
          <a:p>
            <a:r>
              <a:rPr lang="en-US" altLang="zh-CN" sz="1200" i="1" dirty="0"/>
              <a:t>3/4</a:t>
            </a:r>
            <a:r>
              <a:rPr lang="en-US" altLang="zh-CN" sz="1200" dirty="0"/>
              <a:t> </a:t>
            </a:r>
            <a:endParaRPr lang="en-US" sz="1200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1E651E1-09B3-42B8-AFA1-57A2DEA77A87}"/>
              </a:ext>
            </a:extLst>
          </p:cNvPr>
          <p:cNvSpPr/>
          <p:nvPr/>
        </p:nvSpPr>
        <p:spPr>
          <a:xfrm rot="1025403">
            <a:off x="4073892" y="3291459"/>
            <a:ext cx="86563" cy="99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15FAA139-BFD5-4B42-86E5-4C8668A553BB}"/>
              </a:ext>
            </a:extLst>
          </p:cNvPr>
          <p:cNvSpPr/>
          <p:nvPr/>
        </p:nvSpPr>
        <p:spPr>
          <a:xfrm rot="1983946">
            <a:off x="4164241" y="3320868"/>
            <a:ext cx="86563" cy="99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45D5F5A-3F5B-4455-8375-066ADC3772CD}"/>
              </a:ext>
            </a:extLst>
          </p:cNvPr>
          <p:cNvSpPr/>
          <p:nvPr/>
        </p:nvSpPr>
        <p:spPr>
          <a:xfrm rot="20175388">
            <a:off x="3898484" y="3299367"/>
            <a:ext cx="86563" cy="99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264FB2E-7387-420C-848C-EA561DDEEC74}"/>
              </a:ext>
            </a:extLst>
          </p:cNvPr>
          <p:cNvSpPr/>
          <p:nvPr/>
        </p:nvSpPr>
        <p:spPr>
          <a:xfrm rot="19225356">
            <a:off x="3815080" y="3332959"/>
            <a:ext cx="86563" cy="996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6A66EEA-3F8A-4D5D-8309-5FCD4E9CEB21}"/>
              </a:ext>
            </a:extLst>
          </p:cNvPr>
          <p:cNvSpPr txBox="1"/>
          <p:nvPr/>
        </p:nvSpPr>
        <p:spPr>
          <a:xfrm>
            <a:off x="933164" y="756982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</a:rPr>
              <a:t>     WT         </a:t>
            </a:r>
            <a:r>
              <a:rPr lang="en-US" altLang="zh-CN" sz="1200" i="1" dirty="0">
                <a:solidFill>
                  <a:schemeClr val="bg1"/>
                </a:solidFill>
              </a:rPr>
              <a:t>nhx1/2/3/4</a:t>
            </a:r>
            <a:r>
              <a:rPr lang="en-US" altLang="zh-CN" sz="1200" dirty="0">
                <a:solidFill>
                  <a:schemeClr val="bg1"/>
                </a:solidFill>
              </a:rPr>
              <a:t> 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393B98C-C477-4737-9EE5-15ED8DBA2F4F}"/>
              </a:ext>
            </a:extLst>
          </p:cNvPr>
          <p:cNvSpPr txBox="1"/>
          <p:nvPr/>
        </p:nvSpPr>
        <p:spPr>
          <a:xfrm>
            <a:off x="968945" y="2281492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</a:rPr>
              <a:t>     WT         </a:t>
            </a:r>
            <a:r>
              <a:rPr lang="en-US" altLang="zh-CN" sz="1200" i="1" dirty="0">
                <a:solidFill>
                  <a:schemeClr val="bg1"/>
                </a:solidFill>
              </a:rPr>
              <a:t>nhx1/2/3/4</a:t>
            </a:r>
            <a:r>
              <a:rPr lang="en-US" altLang="zh-CN" sz="1200" dirty="0">
                <a:solidFill>
                  <a:schemeClr val="bg1"/>
                </a:solidFill>
              </a:rPr>
              <a:t> 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FD2E98F-2290-4C5A-A7D1-3A8C8B02AB90}"/>
              </a:ext>
            </a:extLst>
          </p:cNvPr>
          <p:cNvSpPr txBox="1"/>
          <p:nvPr/>
        </p:nvSpPr>
        <p:spPr>
          <a:xfrm>
            <a:off x="2829197" y="2283482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</a:rPr>
              <a:t>     WT         </a:t>
            </a:r>
            <a:r>
              <a:rPr lang="en-US" altLang="zh-CN" sz="1200" i="1" dirty="0">
                <a:solidFill>
                  <a:schemeClr val="bg1"/>
                </a:solidFill>
              </a:rPr>
              <a:t>nhx1/2/3/4</a:t>
            </a:r>
            <a:r>
              <a:rPr lang="en-US" altLang="zh-CN" sz="1200" dirty="0">
                <a:solidFill>
                  <a:schemeClr val="bg1"/>
                </a:solidFill>
              </a:rPr>
              <a:t> 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EADF2569-3301-46B6-A48D-8E39B8E5AE67}"/>
              </a:ext>
            </a:extLst>
          </p:cNvPr>
          <p:cNvSpPr/>
          <p:nvPr/>
        </p:nvSpPr>
        <p:spPr>
          <a:xfrm>
            <a:off x="2193464" y="3535800"/>
            <a:ext cx="89358" cy="274549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51FB5A65-3A3E-426C-97D8-9A0D31FB2DCD}"/>
              </a:ext>
            </a:extLst>
          </p:cNvPr>
          <p:cNvSpPr/>
          <p:nvPr/>
        </p:nvSpPr>
        <p:spPr>
          <a:xfrm rot="1263354">
            <a:off x="2085339" y="3514209"/>
            <a:ext cx="89359" cy="317038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2F7B6917-512F-4F78-8982-FC0933BB161B}"/>
              </a:ext>
            </a:extLst>
          </p:cNvPr>
          <p:cNvSpPr/>
          <p:nvPr/>
        </p:nvSpPr>
        <p:spPr>
          <a:xfrm rot="1655575">
            <a:off x="5676485" y="1529993"/>
            <a:ext cx="45719" cy="163147"/>
          </a:xfrm>
          <a:prstGeom prst="ellipse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6C2C76BA-0915-4233-AFF9-7B9DB09C161D}"/>
              </a:ext>
            </a:extLst>
          </p:cNvPr>
          <p:cNvSpPr/>
          <p:nvPr/>
        </p:nvSpPr>
        <p:spPr>
          <a:xfrm rot="7996885">
            <a:off x="5693123" y="1655817"/>
            <a:ext cx="45719" cy="163147"/>
          </a:xfrm>
          <a:prstGeom prst="ellipse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Freeform: Shape 12">
            <a:extLst>
              <a:ext uri="{FF2B5EF4-FFF2-40B4-BE49-F238E27FC236}">
                <a16:creationId xmlns:a16="http://schemas.microsoft.com/office/drawing/2014/main" id="{2497AF11-7B76-4EC0-9093-F1698AEF1648}"/>
              </a:ext>
            </a:extLst>
          </p:cNvPr>
          <p:cNvSpPr/>
          <p:nvPr/>
        </p:nvSpPr>
        <p:spPr>
          <a:xfrm>
            <a:off x="5408833" y="1665036"/>
            <a:ext cx="247332" cy="398738"/>
          </a:xfrm>
          <a:custGeom>
            <a:avLst/>
            <a:gdLst>
              <a:gd name="connsiteX0" fmla="*/ 247332 w 247332"/>
              <a:gd name="connsiteY0" fmla="*/ 17944 h 398738"/>
              <a:gd name="connsiteX1" fmla="*/ 18732 w 247332"/>
              <a:gd name="connsiteY1" fmla="*/ 38264 h 398738"/>
              <a:gd name="connsiteX2" fmla="*/ 13652 w 247332"/>
              <a:gd name="connsiteY2" fmla="*/ 358304 h 398738"/>
              <a:gd name="connsiteX3" fmla="*/ 18732 w 247332"/>
              <a:gd name="connsiteY3" fmla="*/ 383704 h 3987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7332" h="398738">
                <a:moveTo>
                  <a:pt x="247332" y="17944"/>
                </a:moveTo>
                <a:cubicBezTo>
                  <a:pt x="152505" y="-260"/>
                  <a:pt x="57679" y="-18463"/>
                  <a:pt x="18732" y="38264"/>
                </a:cubicBezTo>
                <a:cubicBezTo>
                  <a:pt x="-20215" y="94991"/>
                  <a:pt x="13652" y="300731"/>
                  <a:pt x="13652" y="358304"/>
                </a:cubicBezTo>
                <a:cubicBezTo>
                  <a:pt x="13652" y="415877"/>
                  <a:pt x="16192" y="399790"/>
                  <a:pt x="18732" y="383704"/>
                </a:cubicBezTo>
              </a:path>
            </a:pathLst>
          </a:cu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Arc 17">
            <a:extLst>
              <a:ext uri="{FF2B5EF4-FFF2-40B4-BE49-F238E27FC236}">
                <a16:creationId xmlns:a16="http://schemas.microsoft.com/office/drawing/2014/main" id="{E9F74433-B78C-404E-8393-3DBCBA088114}"/>
              </a:ext>
            </a:extLst>
          </p:cNvPr>
          <p:cNvSpPr/>
          <p:nvPr/>
        </p:nvSpPr>
        <p:spPr>
          <a:xfrm rot="8141718">
            <a:off x="5408506" y="1677677"/>
            <a:ext cx="195086" cy="139745"/>
          </a:xfrm>
          <a:prstGeom prst="arc">
            <a:avLst>
              <a:gd name="adj1" fmla="val 11406515"/>
              <a:gd name="adj2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ADE2AAC-D022-4C1C-93ED-A54A8CA0098B}"/>
              </a:ext>
            </a:extLst>
          </p:cNvPr>
          <p:cNvSpPr txBox="1"/>
          <p:nvPr/>
        </p:nvSpPr>
        <p:spPr>
          <a:xfrm>
            <a:off x="5381899" y="2156158"/>
            <a:ext cx="433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9</a:t>
            </a:r>
            <a:r>
              <a:rPr lang="en-US" sz="1200" dirty="0"/>
              <a:t>0°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5D7727F-B819-47CE-BC7F-1D5193F19D11}"/>
              </a:ext>
            </a:extLst>
          </p:cNvPr>
          <p:cNvSpPr txBox="1"/>
          <p:nvPr/>
        </p:nvSpPr>
        <p:spPr>
          <a:xfrm>
            <a:off x="4741810" y="1647335"/>
            <a:ext cx="520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8</a:t>
            </a:r>
            <a:r>
              <a:rPr lang="en-US" sz="1200" dirty="0"/>
              <a:t>0°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D531CA2-7E6A-48C0-AD96-917BD0568573}"/>
              </a:ext>
            </a:extLst>
          </p:cNvPr>
          <p:cNvSpPr txBox="1"/>
          <p:nvPr/>
        </p:nvSpPr>
        <p:spPr>
          <a:xfrm>
            <a:off x="5338454" y="1148918"/>
            <a:ext cx="520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7</a:t>
            </a:r>
            <a:r>
              <a:rPr lang="en-US" sz="1200" dirty="0"/>
              <a:t>0°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4C8CED9-3A05-43EF-B066-DA3D382308B2}"/>
              </a:ext>
            </a:extLst>
          </p:cNvPr>
          <p:cNvSpPr txBox="1"/>
          <p:nvPr/>
        </p:nvSpPr>
        <p:spPr>
          <a:xfrm>
            <a:off x="5903030" y="1636959"/>
            <a:ext cx="433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°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91B576F9-202B-42BE-A328-424F2663D40A}"/>
              </a:ext>
            </a:extLst>
          </p:cNvPr>
          <p:cNvSpPr txBox="1"/>
          <p:nvPr/>
        </p:nvSpPr>
        <p:spPr>
          <a:xfrm>
            <a:off x="4547684" y="1050425"/>
            <a:ext cx="374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1C19B8FA-C817-41F6-9E69-73E3989F1B8E}"/>
              </a:ext>
            </a:extLst>
          </p:cNvPr>
          <p:cNvSpPr/>
          <p:nvPr/>
        </p:nvSpPr>
        <p:spPr>
          <a:xfrm>
            <a:off x="5459249" y="1740400"/>
            <a:ext cx="2712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solidFill>
                  <a:srgbClr val="333333"/>
                </a:solidFill>
                <a:latin typeface="Roboto"/>
              </a:rPr>
              <a:t>𝜃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164856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95400" y="590550"/>
            <a:ext cx="3663950" cy="2139950"/>
            <a:chOff x="1295400" y="590550"/>
            <a:chExt cx="3663950" cy="2139950"/>
          </a:xfrm>
        </p:grpSpPr>
        <p:graphicFrame>
          <p:nvGraphicFramePr>
            <p:cNvPr id="4" name="Chart 3"/>
            <p:cNvGraphicFramePr>
              <a:graphicFrameLocks/>
            </p:cNvGraphicFramePr>
            <p:nvPr/>
          </p:nvGraphicFramePr>
          <p:xfrm>
            <a:off x="1295400" y="635000"/>
            <a:ext cx="3663950" cy="2095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2457450" y="590550"/>
              <a:ext cx="4127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n.s</a:t>
              </a:r>
              <a:r>
                <a:rPr lang="en-US" sz="1000" dirty="0"/>
                <a:t>.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898900" y="984250"/>
              <a:ext cx="4127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/>
                <a:t>n.s</a:t>
              </a:r>
              <a:r>
                <a:rPr lang="en-US" sz="1000" dirty="0"/>
                <a:t>.</a:t>
              </a: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661419" y="2774950"/>
            <a:ext cx="56663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Figure S2. </a:t>
            </a:r>
            <a:r>
              <a:rPr lang="en-US" altLang="zh-CN" sz="1200" dirty="0"/>
              <a:t>The expression level of </a:t>
            </a:r>
            <a:r>
              <a:rPr lang="en-US" altLang="zh-CN" sz="1200" i="1" dirty="0"/>
              <a:t>PIN1</a:t>
            </a:r>
            <a:r>
              <a:rPr lang="en-US" altLang="zh-CN" sz="1200" dirty="0"/>
              <a:t> and </a:t>
            </a:r>
            <a:r>
              <a:rPr lang="en-US" altLang="zh-CN" sz="1200" i="1" dirty="0"/>
              <a:t>PIN2 </a:t>
            </a:r>
            <a:r>
              <a:rPr lang="en-US" altLang="zh-CN" sz="1200" dirty="0"/>
              <a:t>genes in WT and </a:t>
            </a:r>
            <a:r>
              <a:rPr lang="en-US" sz="1200" i="1" dirty="0"/>
              <a:t>nhx1nhx2nhx3nhx4 </a:t>
            </a:r>
            <a:r>
              <a:rPr lang="en-US" altLang="zh-CN" sz="1200" dirty="0"/>
              <a:t>(</a:t>
            </a:r>
            <a:r>
              <a:rPr lang="en-US" altLang="zh-CN" sz="1200" i="1" dirty="0"/>
              <a:t>nhx1/2/3/4)</a:t>
            </a:r>
            <a:r>
              <a:rPr lang="en-US" altLang="zh-CN" sz="1200" dirty="0"/>
              <a:t> mutant roots. Fold change was measured by qPCR. Values are the Mean ± SD (n = 15). </a:t>
            </a:r>
            <a:r>
              <a:rPr lang="en-US" altLang="zh-CN" sz="1200" dirty="0" err="1"/>
              <a:t>n.s</a:t>
            </a:r>
            <a:r>
              <a:rPr lang="en-US" altLang="zh-CN" sz="1200" dirty="0"/>
              <a:t>., non-significant difference (P&gt;0.05; t test). 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216044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82" t="46545" r="20518" b="7496"/>
          <a:stretch/>
        </p:blipFill>
        <p:spPr>
          <a:xfrm>
            <a:off x="4013029" y="4230697"/>
            <a:ext cx="781741" cy="743839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23" t="43884" r="24526" b="27310"/>
          <a:stretch/>
        </p:blipFill>
        <p:spPr>
          <a:xfrm>
            <a:off x="4008291" y="3505252"/>
            <a:ext cx="786479" cy="729626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4"/>
          <a:srcRect l="37399" t="22155" r="29122" b="46395"/>
          <a:stretch/>
        </p:blipFill>
        <p:spPr>
          <a:xfrm>
            <a:off x="904600" y="2772460"/>
            <a:ext cx="781742" cy="734363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67" t="43284" r="23842" b="20614"/>
          <a:stretch/>
        </p:blipFill>
        <p:spPr>
          <a:xfrm>
            <a:off x="904603" y="3493796"/>
            <a:ext cx="786479" cy="753314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50" t="46823" r="20243" b="7410"/>
          <a:stretch/>
        </p:blipFill>
        <p:spPr>
          <a:xfrm>
            <a:off x="904600" y="4235194"/>
            <a:ext cx="781741" cy="7391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57" t="45989" r="19591" b="6311"/>
          <a:stretch/>
        </p:blipFill>
        <p:spPr>
          <a:xfrm>
            <a:off x="3236448" y="4237586"/>
            <a:ext cx="780036" cy="736061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44" t="45074" r="20174" b="7952"/>
          <a:stretch/>
        </p:blipFill>
        <p:spPr>
          <a:xfrm>
            <a:off x="2462762" y="4230697"/>
            <a:ext cx="781050" cy="74295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9"/>
          <a:srcRect l="37054" t="20566" r="29320" b="47883"/>
          <a:stretch/>
        </p:blipFill>
        <p:spPr>
          <a:xfrm>
            <a:off x="2469897" y="2772460"/>
            <a:ext cx="781050" cy="73287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10"/>
          <a:srcRect t="1499" r="589" b="549"/>
          <a:stretch/>
        </p:blipFill>
        <p:spPr>
          <a:xfrm>
            <a:off x="1099376" y="521192"/>
            <a:ext cx="2780347" cy="2199543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11"/>
          <a:srcRect l="36902" t="21830" r="29766" b="46309"/>
          <a:stretch/>
        </p:blipFill>
        <p:spPr>
          <a:xfrm>
            <a:off x="3241985" y="2772460"/>
            <a:ext cx="774217" cy="738132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2"/>
          <a:srcRect l="36861" t="22434" r="29281" b="45906"/>
          <a:stretch/>
        </p:blipFill>
        <p:spPr>
          <a:xfrm>
            <a:off x="1683268" y="2772460"/>
            <a:ext cx="784402" cy="73342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44" t="44257" r="25195" b="26937"/>
          <a:stretch/>
        </p:blipFill>
        <p:spPr>
          <a:xfrm>
            <a:off x="3245946" y="3504670"/>
            <a:ext cx="775274" cy="73079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08" t="43944" r="24628" b="27374"/>
          <a:stretch/>
        </p:blipFill>
        <p:spPr>
          <a:xfrm>
            <a:off x="2467255" y="3504671"/>
            <a:ext cx="786318" cy="73193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90" t="44274" r="25121" b="26823"/>
          <a:stretch/>
        </p:blipFill>
        <p:spPr>
          <a:xfrm>
            <a:off x="1689431" y="3506853"/>
            <a:ext cx="781556" cy="733681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26" t="46348" r="19074" b="6759"/>
          <a:stretch/>
        </p:blipFill>
        <p:spPr>
          <a:xfrm>
            <a:off x="1682506" y="4235504"/>
            <a:ext cx="786839" cy="737961"/>
          </a:xfrm>
          <a:prstGeom prst="rect">
            <a:avLst/>
          </a:prstGeom>
        </p:spPr>
      </p:pic>
      <p:cxnSp>
        <p:nvCxnSpPr>
          <p:cNvPr id="27" name="Straight Connector 26"/>
          <p:cNvCxnSpPr/>
          <p:nvPr/>
        </p:nvCxnSpPr>
        <p:spPr>
          <a:xfrm>
            <a:off x="899089" y="2768665"/>
            <a:ext cx="0" cy="230499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898186" y="3497442"/>
            <a:ext cx="3896584" cy="14119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898186" y="4237586"/>
            <a:ext cx="3896584" cy="97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840235" y="502784"/>
            <a:ext cx="395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40236" y="2739143"/>
            <a:ext cx="395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(b)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17"/>
          <a:srcRect l="36724" t="22114" r="29648" b="46104"/>
          <a:stretch/>
        </p:blipFill>
        <p:spPr>
          <a:xfrm>
            <a:off x="4011901" y="2772460"/>
            <a:ext cx="777004" cy="734363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4007555" y="3480081"/>
            <a:ext cx="8439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solidFill>
                  <a:schemeClr val="bg1"/>
                </a:solidFill>
              </a:rPr>
              <a:t>nhx1/2/3/4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420709" y="4210246"/>
            <a:ext cx="14924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PIN2-GFP/</a:t>
            </a:r>
            <a:r>
              <a:rPr lang="en-US" sz="1100" i="1" dirty="0">
                <a:solidFill>
                  <a:schemeClr val="bg1"/>
                </a:solidFill>
              </a:rPr>
              <a:t>nhx1/2/3/4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866740" y="2735317"/>
            <a:ext cx="10736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PIN2-GFP/WT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2423029" y="4931205"/>
            <a:ext cx="8605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Background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1689431" y="4931205"/>
            <a:ext cx="7369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PIN2-GFP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300179" y="4931205"/>
            <a:ext cx="7186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Residual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4089404" y="4931205"/>
            <a:ext cx="6300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Overlay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964513" y="4931205"/>
            <a:ext cx="7369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Original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17769" y="5244849"/>
            <a:ext cx="566635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b="1" dirty="0"/>
              <a:t>Figure S3.  </a:t>
            </a:r>
            <a:r>
              <a:rPr lang="en-US" altLang="zh-CN" sz="1200" dirty="0"/>
              <a:t>Alternate method (linear unmixing) used to eliminate the plastid-like bodies in PIN2-GFP/</a:t>
            </a:r>
            <a:r>
              <a:rPr lang="en-US" sz="1200" i="1" dirty="0"/>
              <a:t>nhx1nhx2nhx3nhx4</a:t>
            </a:r>
            <a:r>
              <a:rPr lang="en-US" altLang="zh-CN" sz="1200" dirty="0"/>
              <a:t>. (</a:t>
            </a:r>
            <a:r>
              <a:rPr lang="en-US" altLang="zh-CN" sz="1200" b="1" dirty="0"/>
              <a:t>a</a:t>
            </a:r>
            <a:r>
              <a:rPr lang="en-US" altLang="zh-CN" sz="1200" dirty="0"/>
              <a:t>), estimated spectra of PIN2-GFP and the plastid-like bodies. The spectra was estimated by pointing either the PIN2-GFP or the plastid-like bodies on a series of lambda scan images using the linear </a:t>
            </a:r>
            <a:r>
              <a:rPr lang="en-US" altLang="zh-CN" sz="1200" dirty="0" err="1"/>
              <a:t>unmixing</a:t>
            </a:r>
            <a:r>
              <a:rPr lang="en-US" altLang="zh-CN" sz="1200" dirty="0"/>
              <a:t> function provided</a:t>
            </a:r>
            <a:r>
              <a:rPr lang="zh-CN" altLang="en-US" sz="1200" dirty="0"/>
              <a:t> </a:t>
            </a:r>
            <a:r>
              <a:rPr lang="en-US" altLang="zh-CN" sz="1200" dirty="0"/>
              <a:t>by the Carl Zeiss LSM 710 microscope. (</a:t>
            </a:r>
            <a:r>
              <a:rPr lang="en-US" altLang="zh-CN" sz="1200" b="1" dirty="0"/>
              <a:t>b</a:t>
            </a:r>
            <a:r>
              <a:rPr lang="en-US" altLang="zh-CN" sz="1200" dirty="0"/>
              <a:t>),  demonstration of eliminating the plastid-like bodies in PIN2-GFP/WT, </a:t>
            </a:r>
            <a:r>
              <a:rPr lang="en-US" sz="1200" i="1" dirty="0"/>
              <a:t>nhx1nhx2nhx3nhx4 </a:t>
            </a:r>
            <a:r>
              <a:rPr lang="en-US" altLang="zh-CN" sz="1200" dirty="0"/>
              <a:t>(</a:t>
            </a:r>
            <a:r>
              <a:rPr lang="en-US" altLang="zh-CN" sz="1200" i="1" dirty="0"/>
              <a:t>nhx1/2/3/4</a:t>
            </a:r>
            <a:r>
              <a:rPr lang="en-US" altLang="zh-CN" sz="1200" dirty="0"/>
              <a:t>) and </a:t>
            </a:r>
            <a:r>
              <a:rPr lang="en-US" sz="1200" dirty="0"/>
              <a:t>PIN2-GFP/</a:t>
            </a:r>
            <a:r>
              <a:rPr lang="en-US" sz="1200" i="1" dirty="0"/>
              <a:t>nhx1nhx2nhx3nhx4 </a:t>
            </a:r>
            <a:r>
              <a:rPr lang="en-US" sz="1200" dirty="0"/>
              <a:t>using the linear unmixing function. </a:t>
            </a:r>
          </a:p>
        </p:txBody>
      </p:sp>
    </p:spTree>
    <p:extLst>
      <p:ext uri="{BB962C8B-B14F-4D97-AF65-F5344CB8AC3E}">
        <p14:creationId xmlns:p14="http://schemas.microsoft.com/office/powerpoint/2010/main" val="1440134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D488856-433D-49DD-934F-4E87AA81D72B}"/>
              </a:ext>
            </a:extLst>
          </p:cNvPr>
          <p:cNvSpPr txBox="1"/>
          <p:nvPr/>
        </p:nvSpPr>
        <p:spPr>
          <a:xfrm>
            <a:off x="513274" y="3460499"/>
            <a:ext cx="56663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200" b="1" dirty="0"/>
              <a:t>Figure S4. </a:t>
            </a:r>
            <a:r>
              <a:rPr lang="en-US" altLang="zh-CN" sz="1200" dirty="0"/>
              <a:t>S</a:t>
            </a:r>
            <a:r>
              <a:rPr lang="en-US" sz="1200" dirty="0"/>
              <a:t>ubcellular localization of PIN2 in </a:t>
            </a:r>
            <a:r>
              <a:rPr lang="en-US" sz="1200" i="1" dirty="0"/>
              <a:t>nhx1nhx2nhx3nhx4 </a:t>
            </a:r>
            <a:r>
              <a:rPr lang="en-US" sz="1200" dirty="0"/>
              <a:t>(</a:t>
            </a:r>
            <a:r>
              <a:rPr lang="en-US" sz="1200" i="1" dirty="0"/>
              <a:t>nhx1/2/3/4</a:t>
            </a:r>
            <a:r>
              <a:rPr lang="en-US" sz="1200" dirty="0"/>
              <a:t>)</a:t>
            </a:r>
            <a:r>
              <a:rPr lang="en-US" sz="1200" i="1" dirty="0"/>
              <a:t> </a:t>
            </a:r>
            <a:r>
              <a:rPr lang="en-US" sz="1200" dirty="0"/>
              <a:t>under 1mM K</a:t>
            </a:r>
            <a:r>
              <a:rPr lang="en-US" sz="1200" baseline="30000" dirty="0"/>
              <a:t>+</a:t>
            </a:r>
            <a:r>
              <a:rPr lang="en-US" sz="1200" dirty="0"/>
              <a:t> (</a:t>
            </a:r>
            <a:r>
              <a:rPr lang="en-US" sz="1200" b="1" dirty="0"/>
              <a:t>a</a:t>
            </a:r>
            <a:r>
              <a:rPr lang="en-US" sz="1200" dirty="0"/>
              <a:t>) and 30mM K</a:t>
            </a:r>
            <a:r>
              <a:rPr lang="en-US" sz="1200" baseline="30000" dirty="0"/>
              <a:t> +</a:t>
            </a:r>
            <a:r>
              <a:rPr lang="en-US" sz="1200" dirty="0"/>
              <a:t> (</a:t>
            </a:r>
            <a:r>
              <a:rPr lang="en-US" sz="1200" b="1" dirty="0"/>
              <a:t>b</a:t>
            </a:r>
            <a:r>
              <a:rPr lang="en-US" sz="1200" dirty="0"/>
              <a:t>). Scale bar, 10 µm. </a:t>
            </a:r>
          </a:p>
        </p:txBody>
      </p:sp>
      <p:pic>
        <p:nvPicPr>
          <p:cNvPr id="7" name="Picture 6" descr="A picture containing necktie, person, person, dark&#10;&#10;Description automatically generated">
            <a:extLst>
              <a:ext uri="{FF2B5EF4-FFF2-40B4-BE49-F238E27FC236}">
                <a16:creationId xmlns:a16="http://schemas.microsoft.com/office/drawing/2014/main" id="{B3C570EA-0FB7-44FF-A6DD-6C35EAC08AC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92" t="39685" r="39291" b="16771"/>
          <a:stretch/>
        </p:blipFill>
        <p:spPr>
          <a:xfrm>
            <a:off x="3346452" y="730248"/>
            <a:ext cx="1524000" cy="2420473"/>
          </a:xfrm>
          <a:prstGeom prst="rect">
            <a:avLst/>
          </a:prstGeom>
        </p:spPr>
      </p:pic>
      <p:pic>
        <p:nvPicPr>
          <p:cNvPr id="9" name="Picture 8" descr="A picture containing dark, person, green, door&#10;&#10;Description automatically generated">
            <a:extLst>
              <a:ext uri="{FF2B5EF4-FFF2-40B4-BE49-F238E27FC236}">
                <a16:creationId xmlns:a16="http://schemas.microsoft.com/office/drawing/2014/main" id="{6DAA33B5-3459-4FEB-8ED7-6623889CB80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570" t="24249" r="42013" b="32206"/>
          <a:stretch/>
        </p:blipFill>
        <p:spPr>
          <a:xfrm>
            <a:off x="1746248" y="730248"/>
            <a:ext cx="1524001" cy="242047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044F072-C371-42CB-94D7-6691611BBAF8}"/>
              </a:ext>
            </a:extLst>
          </p:cNvPr>
          <p:cNvSpPr txBox="1"/>
          <p:nvPr/>
        </p:nvSpPr>
        <p:spPr>
          <a:xfrm>
            <a:off x="1746248" y="730248"/>
            <a:ext cx="395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(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95E2EFD-5AA6-4304-B660-791F708B9F5E}"/>
              </a:ext>
            </a:extLst>
          </p:cNvPr>
          <p:cNvSpPr txBox="1"/>
          <p:nvPr/>
        </p:nvSpPr>
        <p:spPr>
          <a:xfrm>
            <a:off x="3346452" y="730247"/>
            <a:ext cx="395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(</a:t>
            </a:r>
            <a:r>
              <a:rPr lang="en-US" altLang="zh-CN" sz="1200" b="1" dirty="0">
                <a:solidFill>
                  <a:schemeClr val="bg1"/>
                </a:solidFill>
              </a:rPr>
              <a:t>b</a:t>
            </a:r>
            <a:r>
              <a:rPr lang="en-US" sz="1200" b="1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DB53C36-587B-4B92-9740-C1C4E6D60A45}"/>
              </a:ext>
            </a:extLst>
          </p:cNvPr>
          <p:cNvSpPr txBox="1"/>
          <p:nvPr/>
        </p:nvSpPr>
        <p:spPr>
          <a:xfrm>
            <a:off x="2611583" y="2886867"/>
            <a:ext cx="861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1mM K</a:t>
            </a:r>
            <a:r>
              <a:rPr lang="en-US" sz="1200" b="1" baseline="30000" dirty="0">
                <a:solidFill>
                  <a:schemeClr val="bg1"/>
                </a:solidFill>
              </a:rPr>
              <a:t> +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FC55F28-BE37-4F2F-93DC-79D7E90F862E}"/>
              </a:ext>
            </a:extLst>
          </p:cNvPr>
          <p:cNvSpPr txBox="1"/>
          <p:nvPr/>
        </p:nvSpPr>
        <p:spPr>
          <a:xfrm>
            <a:off x="4122888" y="2880294"/>
            <a:ext cx="861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30mM K</a:t>
            </a:r>
            <a:r>
              <a:rPr lang="en-US" sz="1200" b="1" baseline="30000" dirty="0">
                <a:solidFill>
                  <a:schemeClr val="bg1"/>
                </a:solidFill>
              </a:rPr>
              <a:t> +</a:t>
            </a:r>
            <a:endParaRPr lang="en-US" sz="1200" b="1" dirty="0">
              <a:solidFill>
                <a:schemeClr val="bg1"/>
              </a:solidFill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A3D10A1-411E-4CF5-AAF0-C623D505A9DB}"/>
              </a:ext>
            </a:extLst>
          </p:cNvPr>
          <p:cNvCxnSpPr>
            <a:cxnSpLocks/>
          </p:cNvCxnSpPr>
          <p:nvPr/>
        </p:nvCxnSpPr>
        <p:spPr>
          <a:xfrm>
            <a:off x="1849467" y="3025366"/>
            <a:ext cx="43212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072AFF2-E059-46DA-93B9-D7261BB8A31F}"/>
              </a:ext>
            </a:extLst>
          </p:cNvPr>
          <p:cNvCxnSpPr>
            <a:cxnSpLocks/>
          </p:cNvCxnSpPr>
          <p:nvPr/>
        </p:nvCxnSpPr>
        <p:spPr>
          <a:xfrm>
            <a:off x="3429000" y="3025366"/>
            <a:ext cx="43212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72512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504</TotalTime>
  <Words>379</Words>
  <Application>Microsoft Office PowerPoint</Application>
  <PresentationFormat>Letter Paper (8.5x11 in)</PresentationFormat>
  <Paragraphs>42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Roboto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qi Zhang</dc:creator>
  <cp:lastModifiedBy>Shiqi Zhang</cp:lastModifiedBy>
  <cp:revision>158</cp:revision>
  <dcterms:created xsi:type="dcterms:W3CDTF">2020-03-27T12:25:43Z</dcterms:created>
  <dcterms:modified xsi:type="dcterms:W3CDTF">2020-09-01T23:57:37Z</dcterms:modified>
</cp:coreProperties>
</file>